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51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03" userDrawn="1">
          <p15:clr>
            <a:srgbClr val="A4A3A4"/>
          </p15:clr>
        </p15:guide>
        <p15:guide id="2" pos="49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605"/>
    <a:srgbClr val="C00000"/>
    <a:srgbClr val="FF40FF"/>
    <a:srgbClr val="4B4D48"/>
    <a:srgbClr val="00FA00"/>
    <a:srgbClr val="2A2D2E"/>
    <a:srgbClr val="151618"/>
    <a:srgbClr val="0B0D0C"/>
    <a:srgbClr val="FEFEB5"/>
    <a:srgbClr val="3A4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87"/>
    <p:restoredTop sz="94674"/>
  </p:normalViewPr>
  <p:slideViewPr>
    <p:cSldViewPr snapToGrid="0" snapToObjects="1" showGuides="1">
      <p:cViewPr varScale="1">
        <p:scale>
          <a:sx n="86" d="100"/>
          <a:sy n="86" d="100"/>
        </p:scale>
        <p:origin x="706" y="58"/>
      </p:cViewPr>
      <p:guideLst>
        <p:guide orient="horz" pos="3203"/>
        <p:guide pos="497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68E5A9-6865-E843-AD5B-D45A765191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5BF85F4-80AB-324D-8DCC-213B45408A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C961BC-B663-C840-8475-FE2FE4217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A0B95B1-A8FB-8B47-8C77-F094D1EF2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3C56F1-B73F-EE40-BED1-D707FDFC6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2702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9534EE-3981-AD40-AE86-E39E196D9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930A63F-6DFB-4C49-B7AC-48054C1F69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E6BA072-3C7D-5340-A0E8-959B74EBD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19EC189-3712-1047-AB71-8B70D9ED3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1ED3277-5440-0246-9789-CAAB55AD9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0133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7DB6FE4-6C65-0742-A616-FF4E459E5F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41C321-C627-FE40-A4CE-D44E0CADB1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4C66E2C-B215-CE45-A3CE-75C27811B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0F1E23-BA6C-3348-A5A8-59EB08FA3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70EF7D8-A1A1-FC42-9448-8C975A68B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750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CB322E-D6B4-1340-8695-3ADB02073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196A476-42DB-7746-BC70-D2723BCFEE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45608F-48D0-F943-B9F1-0B80D6E6A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ED7AAB8-0E97-2145-A53F-7DE4BBD82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108D64-57FC-1741-8BD0-743E545C6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6353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8048FE-6820-4249-B4C6-A6721B7C87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F23CC57-31E3-DF40-AC58-9853743FE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D1C9CAD-62EC-9C4A-AF4D-B9C10CA90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686A20-CFDF-AD46-A866-4BE5C13FA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732D183-5830-9148-9802-08C64EE47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2607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855E87D-8893-7448-83F7-C88252E0A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8E6F8BE-23E2-EE4F-91B3-C85FADB127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2C753E5-6327-394C-83A6-D7C1F901C4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730A73D-5FB7-214C-9269-5946BDC25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47798F2-7365-2044-BB7A-022B8DFE3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DBBB3DE-082B-DD43-908C-878FE87C0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8112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E3854E7-C3AF-824D-B72C-89E53FC1D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4816CA4-F3C7-AA48-A0EA-5E109E5A2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D23ADD6-EF35-AF4E-8786-435F6461D6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1E589D7-B72A-FC4D-BDD8-932A501CB4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ACB72D7-0E15-DA41-9650-5B71C0E78D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8B50800-770D-3E45-BCE5-06D410275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FBBD1A9-E8DF-F34B-93C8-2F51C7989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78AAADFF-036F-6E4C-8C3C-D5FEF58A3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3955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E8457D7-C50C-B742-ACB7-B0DD067B4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B1ABEB7-19E4-3B45-B8D7-D92E51232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6DC5E37-18B1-6441-9EC0-34F96B538B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8B451CF-E047-4F41-9671-5A0D496D6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7270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FCE2664-D463-8F45-AEDB-F1ED0A915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EFDB708-1CA9-734C-B980-B8B471199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9EEACAD-DB34-4E41-945C-C7A69C7EB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3920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CB13153-607E-8740-8517-96B89A30C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CF74A9C-BE8A-944F-B492-8285077B43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4E8B0C5-B1DA-EE40-B697-3CC403A224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F023AE3-C44D-884D-B1FF-9EF8FC6BF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FCB7D7A-6327-9149-B096-8AFC9D2C5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95B7247-E469-3845-B272-CF0A7C139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949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1C50EEA-FA61-A040-B08A-2273B69B4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770032F-D7FD-6E40-8A00-A8F832D495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1EAC968-A568-2843-95D1-BE324E53B5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447C3D4-A359-804B-8002-FDBF5B022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6969058-B71A-4E4D-A21D-3368E4EBC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6E7E85-3E2C-7E45-A93A-9D19A8D53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9617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2B8B5FF-A6F2-404E-9075-1C288A3F68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F97547A-83FF-BD49-BE22-E1C76651FF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FE1CA4-8146-0342-8F12-824B50F73E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D2A8C8A-E044-0B41-9FD4-ADDC703DB7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3FC04A-42FD-5B41-B2CF-734AC79DB6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7654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 24">
            <a:extLst>
              <a:ext uri="{FF2B5EF4-FFF2-40B4-BE49-F238E27FC236}">
                <a16:creationId xmlns:a16="http://schemas.microsoft.com/office/drawing/2014/main" id="{D9F333DA-841B-4848-9392-062762108C2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76474" y="872836"/>
            <a:ext cx="6784477" cy="51123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74BAAF9-BDA2-4540-BF57-617F461774F8}"/>
              </a:ext>
            </a:extLst>
          </p:cNvPr>
          <p:cNvSpPr txBox="1"/>
          <p:nvPr/>
        </p:nvSpPr>
        <p:spPr>
          <a:xfrm>
            <a:off x="834501" y="429658"/>
            <a:ext cx="84514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T-coffee Expresso output using processed AtPAP8 and the RDR as in the accession pdb.4K50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305769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85</TotalTime>
  <Words>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DPI-136</cp:lastModifiedBy>
  <cp:revision>38</cp:revision>
  <cp:lastPrinted>2021-12-03T16:59:52Z</cp:lastPrinted>
  <dcterms:created xsi:type="dcterms:W3CDTF">2021-11-12T15:38:55Z</dcterms:created>
  <dcterms:modified xsi:type="dcterms:W3CDTF">2022-03-11T10:17:10Z</dcterms:modified>
</cp:coreProperties>
</file>